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01F595-E94D-4155-B84B-61BD2F0296C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F24930-276D-4FDD-BA59-8FA9BC7BA6D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599D87-1AFB-4640-8670-6EF0B180B73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9544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6232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2856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9544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6232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716259-70D5-4C35-8853-BDA28347CC9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DC1641-CBE6-405D-A780-762DFE00CA0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39EFA2-B956-4762-8189-4E3815CEA99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D54A6F-C2D7-492D-8B5A-A36D42929D3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753801-56DD-4EEB-9A9A-9652F529AF5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28560" y="365040"/>
            <a:ext cx="788688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3054B2-B3C3-42C7-9A1E-E145BC4B006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62B1F1-0D64-4482-B46C-3B1CEAF95C0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4DD574-F7E9-487B-BABE-09D34CC1BD7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94EBD0-8419-4A11-AB58-FF18E31137D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2820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4B769F9-AB5A-40C2-8236-E832CECBEE1C}" type="datetime">
              <a:rPr b="0" lang="zh-CN" sz="1200" spc="-1" strike="noStrike">
                <a:solidFill>
                  <a:srgbClr val="898989"/>
                </a:solidFill>
                <a:latin typeface="Calibri"/>
              </a:rPr>
              <a:t>26/8/29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029040" y="6356520"/>
            <a:ext cx="30859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45768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F97B5DF-5C21-4048-8E76-AAF3B46A8EFC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直线连接符 1"/>
          <p:cNvSpPr/>
          <p:nvPr/>
        </p:nvSpPr>
        <p:spPr>
          <a:xfrm>
            <a:off x="333360" y="2076480"/>
            <a:ext cx="85075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直线连接符 23"/>
          <p:cNvSpPr/>
          <p:nvPr/>
        </p:nvSpPr>
        <p:spPr>
          <a:xfrm>
            <a:off x="303120" y="3367080"/>
            <a:ext cx="8537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直线连接符 24"/>
          <p:cNvSpPr/>
          <p:nvPr/>
        </p:nvSpPr>
        <p:spPr>
          <a:xfrm>
            <a:off x="272880" y="1641600"/>
            <a:ext cx="85680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文本框 65"/>
          <p:cNvSpPr/>
          <p:nvPr/>
        </p:nvSpPr>
        <p:spPr>
          <a:xfrm>
            <a:off x="250920" y="1230480"/>
            <a:ext cx="8340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SUPPLEMENTARY TABLE 4</a:t>
            </a:r>
            <a:r>
              <a:rPr b="1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 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Primer Information (Wild-type Plasmid Construction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文本框 60"/>
          <p:cNvSpPr/>
          <p:nvPr/>
        </p:nvSpPr>
        <p:spPr>
          <a:xfrm>
            <a:off x="1130400" y="2317680"/>
            <a:ext cx="6627600" cy="30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54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5</a:t>
            </a:r>
            <a:r>
              <a:rPr b="0" lang="zh-CN" sz="1300" spc="-1" strike="noStrike">
                <a:solidFill>
                  <a:srgbClr val="000000"/>
                </a:solidFill>
                <a:latin typeface="Times New Roman"/>
              </a:rPr>
              <a:t>′</a:t>
            </a: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‑AAGCTTGGTACCGAGCTC</a:t>
            </a:r>
            <a:r>
              <a:rPr b="0" lang="en-US" sz="1300" spc="-1" strike="noStrike" u="sng">
                <a:solidFill>
                  <a:srgbClr val="000000"/>
                </a:solidFill>
                <a:uFillTx/>
                <a:latin typeface="Times New Roman"/>
                <a:ea typeface="微软雅黑"/>
              </a:rPr>
              <a:t>GGATCC</a:t>
            </a: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CATGGCTGTTAGGGAACCTGACCATCTG‑3</a:t>
            </a:r>
            <a:r>
              <a:rPr b="0" lang="zh-CN" sz="1300" spc="-1" strike="noStrike">
                <a:solidFill>
                  <a:srgbClr val="000000"/>
                </a:solidFill>
                <a:latin typeface="Times New Roman"/>
              </a:rPr>
              <a:t>′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文本框 61"/>
          <p:cNvSpPr/>
          <p:nvPr/>
        </p:nvSpPr>
        <p:spPr>
          <a:xfrm>
            <a:off x="622440" y="2325600"/>
            <a:ext cx="35856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F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文本框 62"/>
          <p:cNvSpPr/>
          <p:nvPr/>
        </p:nvSpPr>
        <p:spPr>
          <a:xfrm>
            <a:off x="7697880" y="2214360"/>
            <a:ext cx="1081080" cy="317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504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BamHI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文本框 34"/>
          <p:cNvSpPr/>
          <p:nvPr/>
        </p:nvSpPr>
        <p:spPr>
          <a:xfrm>
            <a:off x="390600" y="1704960"/>
            <a:ext cx="8236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direction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文本框 37"/>
          <p:cNvSpPr/>
          <p:nvPr/>
        </p:nvSpPr>
        <p:spPr>
          <a:xfrm>
            <a:off x="7311960" y="1706400"/>
            <a:ext cx="15638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Restriction enzyme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文本框 10"/>
          <p:cNvSpPr/>
          <p:nvPr/>
        </p:nvSpPr>
        <p:spPr>
          <a:xfrm>
            <a:off x="3871800" y="1716120"/>
            <a:ext cx="11368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sequence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文本框 30"/>
          <p:cNvSpPr/>
          <p:nvPr/>
        </p:nvSpPr>
        <p:spPr>
          <a:xfrm>
            <a:off x="622440" y="2825640"/>
            <a:ext cx="35856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R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文本框 35"/>
          <p:cNvSpPr/>
          <p:nvPr/>
        </p:nvSpPr>
        <p:spPr>
          <a:xfrm>
            <a:off x="1130400" y="2816280"/>
            <a:ext cx="6808680" cy="30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54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5</a:t>
            </a:r>
            <a:r>
              <a:rPr b="0" lang="zh-CN" sz="1300" spc="-1" strike="noStrike">
                <a:solidFill>
                  <a:srgbClr val="000000"/>
                </a:solidFill>
                <a:latin typeface="Times New Roman"/>
              </a:rPr>
              <a:t>′</a:t>
            </a: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‑TTAAACGGGCCCTCTAGA</a:t>
            </a:r>
            <a:r>
              <a:rPr b="0" lang="en-US" sz="1300" spc="-1" strike="noStrike" u="sng">
                <a:solidFill>
                  <a:srgbClr val="000000"/>
                </a:solidFill>
                <a:uFillTx/>
                <a:latin typeface="Times New Roman"/>
                <a:ea typeface="微软雅黑"/>
              </a:rPr>
              <a:t>CTCGAG</a:t>
            </a: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TTCTTGATGGCAAACACAGTTAACCCAATG‑3</a:t>
            </a:r>
            <a:r>
              <a:rPr b="0" lang="zh-CN" sz="1300" spc="-1" strike="noStrike">
                <a:solidFill>
                  <a:srgbClr val="000000"/>
                </a:solidFill>
                <a:latin typeface="Times New Roman"/>
              </a:rPr>
              <a:t>′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文本框 36"/>
          <p:cNvSpPr/>
          <p:nvPr/>
        </p:nvSpPr>
        <p:spPr>
          <a:xfrm>
            <a:off x="7724880" y="2758680"/>
            <a:ext cx="1079280" cy="317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504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XhoI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文本框 2"/>
          <p:cNvSpPr/>
          <p:nvPr/>
        </p:nvSpPr>
        <p:spPr>
          <a:xfrm>
            <a:off x="565200" y="3451320"/>
            <a:ext cx="7493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Note: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underlined portions indicate the “BamHI site” and “XhoI site”, respectively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3-08-09T12:44:00Z</dcterms:created>
  <dc:creator>ghl</dc:creator>
  <dc:description/>
  <dc:language>en-US</dc:language>
  <cp:lastModifiedBy>墨铁</cp:lastModifiedBy>
  <dcterms:modified xsi:type="dcterms:W3CDTF">2026-05-25T09:44:43Z</dcterms:modified>
  <cp:revision>57</cp:revision>
  <dc:subject/>
  <dc:title/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4EF8A1A72F364BE3A5218373BDAA2C6E_13</vt:lpwstr>
  </property>
  <property fmtid="{D5CDD505-2E9C-101B-9397-08002B2CF9AE}" pid="3" name="KSOProductBuildVer">
    <vt:lpwstr>2052-12.1.0.26375</vt:lpwstr>
  </property>
</Properties>
</file>